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428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34B47-6386-4A76-B167-F0D4365222E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0AB7D1-A79E-47F5-9F89-7C69250E7B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3520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285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5782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4649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3678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1616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9026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394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9622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4622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7734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9323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58281E-44B7-4041-9BC6-28148014D952}" type="datetimeFigureOut">
              <a:rPr kumimoji="1" lang="ja-JP" altLang="en-US" smtClean="0"/>
              <a:t>2025/8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2B4535-17BE-4763-81EF-C591905D17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1152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6C0AD19-AE68-8C22-D56D-E180775B2F5A}"/>
              </a:ext>
            </a:extLst>
          </p:cNvPr>
          <p:cNvSpPr txBox="1"/>
          <p:nvPr/>
        </p:nvSpPr>
        <p:spPr>
          <a:xfrm>
            <a:off x="151139" y="431479"/>
            <a:ext cx="4722622" cy="64633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B</a:t>
            </a: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7CF30599-DC6D-93EA-F580-14C9F75823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6756202"/>
              </p:ext>
            </p:extLst>
          </p:nvPr>
        </p:nvGraphicFramePr>
        <p:xfrm>
          <a:off x="481013" y="3322869"/>
          <a:ext cx="3198812" cy="3027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1" name="Prism 9" r:id="rId3" imgW="3197114" imgH="3024757" progId="Prism9.Document">
                  <p:embed/>
                </p:oleObj>
              </mc:Choice>
              <mc:Fallback>
                <p:oleObj name="Prism 9" r:id="rId3" imgW="3197114" imgH="3024757" progId="Prism9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D92B0944-D71F-922C-5967-42ABAC6F1B3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1013" y="3322869"/>
                        <a:ext cx="3198812" cy="30273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2643339-002F-10D9-6DE7-D4CD07EADFF9}"/>
              </a:ext>
            </a:extLst>
          </p:cNvPr>
          <p:cNvSpPr txBox="1"/>
          <p:nvPr/>
        </p:nvSpPr>
        <p:spPr>
          <a:xfrm>
            <a:off x="3253105" y="935690"/>
            <a:ext cx="1317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Neutron Fluenc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62F21F7-3B46-9DE7-7F84-22968E7203E5}"/>
              </a:ext>
            </a:extLst>
          </p:cNvPr>
          <p:cNvSpPr txBox="1"/>
          <p:nvPr/>
        </p:nvSpPr>
        <p:spPr>
          <a:xfrm>
            <a:off x="207817" y="152400"/>
            <a:ext cx="33549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 Figure S6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8EF4D93A-8F18-0D33-4496-746A1DBF29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6836831"/>
              </p:ext>
            </p:extLst>
          </p:nvPr>
        </p:nvGraphicFramePr>
        <p:xfrm>
          <a:off x="3310253" y="1248614"/>
          <a:ext cx="2743200" cy="1013460"/>
        </p:xfrm>
        <a:graphic>
          <a:graphicData uri="http://schemas.openxmlformats.org/drawingml/2006/table">
            <a:tbl>
              <a:tblPr/>
              <a:tblGrid>
                <a:gridCol w="746760">
                  <a:extLst>
                    <a:ext uri="{9D8B030D-6E8A-4147-A177-3AD203B41FA5}">
                      <a16:colId xmlns:a16="http://schemas.microsoft.com/office/drawing/2014/main" val="2911628610"/>
                    </a:ext>
                  </a:extLst>
                </a:gridCol>
                <a:gridCol w="1082040">
                  <a:extLst>
                    <a:ext uri="{9D8B030D-6E8A-4147-A177-3AD203B41FA5}">
                      <a16:colId xmlns:a16="http://schemas.microsoft.com/office/drawing/2014/main" val="828452214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4246525347"/>
                    </a:ext>
                  </a:extLst>
                </a:gridCol>
              </a:tblGrid>
              <a:tr h="25146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　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Thermal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Epi-thermal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19815562"/>
                  </a:ext>
                </a:extLst>
              </a:tr>
              <a:tr h="2514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Fuc-BSH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.34E+1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.34E+1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1063607"/>
                  </a:ext>
                </a:extLst>
              </a:tr>
              <a:tr h="25146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BPA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.48E+1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.61E+1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16369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Control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2.32E+1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4.30E+1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6730966"/>
                  </a:ext>
                </a:extLst>
              </a:tr>
            </a:tbl>
          </a:graphicData>
        </a:graphic>
      </p:graphicFrame>
      <p:graphicFrame>
        <p:nvGraphicFramePr>
          <p:cNvPr id="9" name="表 8">
            <a:extLst>
              <a:ext uri="{FF2B5EF4-FFF2-40B4-BE49-F238E27FC236}">
                <a16:creationId xmlns:a16="http://schemas.microsoft.com/office/drawing/2014/main" id="{E292B576-9D7C-521A-9D76-6A139B265D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8587962"/>
              </p:ext>
            </p:extLst>
          </p:nvPr>
        </p:nvGraphicFramePr>
        <p:xfrm>
          <a:off x="819557" y="761620"/>
          <a:ext cx="1356592" cy="1853031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25307">
                  <a:extLst>
                    <a:ext uri="{9D8B030D-6E8A-4147-A177-3AD203B41FA5}">
                      <a16:colId xmlns:a16="http://schemas.microsoft.com/office/drawing/2014/main" val="1750908571"/>
                    </a:ext>
                  </a:extLst>
                </a:gridCol>
                <a:gridCol w="370910">
                  <a:extLst>
                    <a:ext uri="{9D8B030D-6E8A-4147-A177-3AD203B41FA5}">
                      <a16:colId xmlns:a16="http://schemas.microsoft.com/office/drawing/2014/main" val="3954982664"/>
                    </a:ext>
                  </a:extLst>
                </a:gridCol>
                <a:gridCol w="460375">
                  <a:extLst>
                    <a:ext uri="{9D8B030D-6E8A-4147-A177-3AD203B41FA5}">
                      <a16:colId xmlns:a16="http://schemas.microsoft.com/office/drawing/2014/main" val="15875362"/>
                    </a:ext>
                  </a:extLst>
                </a:gridCol>
              </a:tblGrid>
              <a:tr h="187839">
                <a:tc>
                  <a:txBody>
                    <a:bodyPr/>
                    <a:lstStyle/>
                    <a:p>
                      <a:pPr algn="ctr" fontAlgn="ctr"/>
                      <a:endParaRPr lang="ja-JP" altLang="en-US" sz="5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uc</a:t>
                      </a:r>
                      <a:r>
                        <a:rPr lang="en-US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BSH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441552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rmal neutron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3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5599009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i-thermal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0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8491504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st neutron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103635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 ray dos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.4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2435850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ron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6.1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136691"/>
                  </a:ext>
                </a:extLst>
              </a:tr>
              <a:tr h="27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dos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1.0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34" charset="-128"/>
                          <a:cs typeface="Arial" panose="020B0604020202020204" pitchFamily="34" charset="0"/>
                        </a:rPr>
                        <a:t>7.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7621284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181C603-86C1-392D-E887-D3979A85C888}"/>
              </a:ext>
            </a:extLst>
          </p:cNvPr>
          <p:cNvSpPr txBox="1"/>
          <p:nvPr/>
        </p:nvSpPr>
        <p:spPr>
          <a:xfrm>
            <a:off x="1386901" y="2614651"/>
            <a:ext cx="78924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unit: Gy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9776E7D-F6EF-1522-01F3-F4EC4C8F0FA0}"/>
              </a:ext>
            </a:extLst>
          </p:cNvPr>
          <p:cNvSpPr txBox="1"/>
          <p:nvPr/>
        </p:nvSpPr>
        <p:spPr>
          <a:xfrm>
            <a:off x="5133535" y="2262528"/>
            <a:ext cx="91991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(unit: cm</a:t>
            </a:r>
            <a:r>
              <a:rPr kumimoji="1" lang="en-US" altLang="ja-JP" sz="1050" baseline="3000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8633DE7-04EC-4E63-BE6C-AB8D7018EDF1}"/>
              </a:ext>
            </a:extLst>
          </p:cNvPr>
          <p:cNvSpPr txBox="1"/>
          <p:nvPr/>
        </p:nvSpPr>
        <p:spPr>
          <a:xfrm>
            <a:off x="295686" y="7490915"/>
            <a:ext cx="626662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.</a:t>
            </a:r>
            <a:r>
              <a: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iodistribution and irradiation dosimetry in a CA19-9–positive in vivo cholangiocarcinoma model treated with fucose-BSH–mediated BNCT.</a:t>
            </a:r>
            <a:b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A) Raw boron dosimetry data in HuCCT-1 xenograft-bearing mice after treatment with fucose-BSH–BNCT. (B) Neutron fluence (cm⁻²) measured in mice receiving either fucose-BSH or BPA as the boron carrier. (C) Calculated BNCT dose (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 for each tissue, determined as the sum of absorbed doses from thermal, epithermal, and fast neutrons, gamma rays, and boron reaction contributions.</a:t>
            </a:r>
            <a:b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ice were implanted with CA19-9–producing HuCCT-1 cells in the right thigh and received intraperitoneal fucose-BSH (100 mg/kg) prior to neutron irradiation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27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5734</TotalTime>
  <Words>206</Words>
  <Application>Microsoft Office PowerPoint</Application>
  <PresentationFormat>A4 210 x 297 mm</PresentationFormat>
  <Paragraphs>58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rism 9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金平 典之</dc:creator>
  <cp:lastModifiedBy>道上 宏之</cp:lastModifiedBy>
  <cp:revision>194</cp:revision>
  <dcterms:created xsi:type="dcterms:W3CDTF">2022-06-29T03:55:00Z</dcterms:created>
  <dcterms:modified xsi:type="dcterms:W3CDTF">2025-08-06T07:14:48Z</dcterms:modified>
</cp:coreProperties>
</file>